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48870-D4A4-4490-BA25-1AB20EEEF9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CF348-6532-422B-9178-56E2FAAD8D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1E9F35-EA62-4E44-8064-469251DCE3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55627-8A5C-4E0E-9DAC-7E75D804DD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1E5B1-3638-4C81-BF82-B360E28C9B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C2F1C-E1BD-4E5B-A80E-BEFA04F3C4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BE38F-B1A5-4485-8C30-57074B5240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2173B-E2BE-4AA0-B84C-17BCD593F2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0913D-8AFA-45A0-B159-35DC9724BB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51E1D-11C1-4104-AFFB-1320634E38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C5D25-C7C4-4F5B-82A6-8705CDCAEA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B2DC5-3200-4C71-844C-BB1B7995EE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6B9782-D5C0-41F0-B7E8-EEB431449019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00040" y="1144440"/>
            <a:ext cx="5959440" cy="6576480"/>
            <a:chOff x="500040" y="1144440"/>
            <a:chExt cx="5959440" cy="6576480"/>
          </a:xfrm>
        </p:grpSpPr>
        <p:sp>
          <p:nvSpPr>
            <p:cNvPr id="42" name=""/>
            <p:cNvSpPr/>
            <p:nvPr/>
          </p:nvSpPr>
          <p:spPr>
            <a:xfrm>
              <a:off x="838080" y="1212840"/>
              <a:ext cx="1533600" cy="1203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838080" y="2179800"/>
              <a:ext cx="1533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838080" y="1932120"/>
              <a:ext cx="1533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838080" y="1693800"/>
              <a:ext cx="1533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838080" y="1449360"/>
              <a:ext cx="1533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838080" y="1212840"/>
              <a:ext cx="1533600" cy="1203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063800" y="2179800"/>
              <a:ext cx="309240" cy="2365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830240" y="1805040"/>
              <a:ext cx="309600" cy="6112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"/>
            <p:cNvSpPr/>
            <p:nvPr/>
          </p:nvSpPr>
          <p:spPr>
            <a:xfrm flipV="1">
              <a:off x="1216080" y="2123640"/>
              <a:ext cx="0" cy="55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200240" y="2124000"/>
              <a:ext cx="349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1982880" y="1285920"/>
              <a:ext cx="1440" cy="519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967040" y="128592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216080" y="2179800"/>
              <a:ext cx="0" cy="72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200240" y="2252520"/>
              <a:ext cx="34920" cy="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82880" y="1805040"/>
              <a:ext cx="1440" cy="293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967040" y="209880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1604880" y="2379600"/>
              <a:ext cx="180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865440" y="1254240"/>
              <a:ext cx="227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IAA1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50240" y="23623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50240" y="21240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50240" y="18795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50240" y="1641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50240" y="13939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750240" y="11574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096560" y="24192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906920" y="2419200"/>
              <a:ext cx="185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IAA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1440" y="174996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908440" y="1211400"/>
              <a:ext cx="1463400" cy="1203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908440" y="2268360"/>
              <a:ext cx="1463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908440" y="2112840"/>
              <a:ext cx="14634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908440" y="1968480"/>
              <a:ext cx="1463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908440" y="1812960"/>
              <a:ext cx="1463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908440" y="1666800"/>
              <a:ext cx="1463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908440" y="1512720"/>
              <a:ext cx="1463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908440" y="1366920"/>
              <a:ext cx="1463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908440" y="1211400"/>
              <a:ext cx="1463400" cy="1203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125880" y="2112840"/>
              <a:ext cx="293760" cy="3016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857760" y="1576440"/>
              <a:ext cx="291960" cy="8380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3271680" y="2050920"/>
              <a:ext cx="1800" cy="61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257640" y="2050920"/>
              <a:ext cx="331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4003560" y="1273320"/>
              <a:ext cx="0" cy="30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989520" y="1273320"/>
              <a:ext cx="34920" cy="4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271680" y="2112840"/>
              <a:ext cx="1800" cy="101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257640" y="2214720"/>
              <a:ext cx="331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003560" y="1576440"/>
              <a:ext cx="0" cy="226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989520" y="1803240"/>
              <a:ext cx="349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3639960" y="2379240"/>
              <a:ext cx="1800" cy="34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944080" y="1200240"/>
              <a:ext cx="25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ARR4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834280" y="2352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834280" y="20527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834280" y="17524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834280" y="14479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834280" y="11476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147480" y="240984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839760" y="2409840"/>
              <a:ext cx="334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Zeatin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2089080" y="174996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919760" y="1200240"/>
              <a:ext cx="1533600" cy="1203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919760" y="2205000"/>
              <a:ext cx="1533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919760" y="2003400"/>
              <a:ext cx="1533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919760" y="1801800"/>
              <a:ext cx="1533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919760" y="1600200"/>
              <a:ext cx="1533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919760" y="1401840"/>
              <a:ext cx="1533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919760" y="1200240"/>
              <a:ext cx="1533600" cy="1203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146560" y="2205000"/>
              <a:ext cx="308160" cy="198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913360" y="1738440"/>
              <a:ext cx="308160" cy="6649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5297400" y="2157480"/>
              <a:ext cx="180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281560" y="215748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6064200" y="1318680"/>
              <a:ext cx="1800" cy="419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6048360" y="1319040"/>
              <a:ext cx="349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297400" y="2205000"/>
              <a:ext cx="1800" cy="61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281560" y="226692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6064200" y="1738440"/>
              <a:ext cx="1800" cy="255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6048360" y="199404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5686560" y="2366640"/>
              <a:ext cx="144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967280" y="1216080"/>
              <a:ext cx="253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BAS1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836240" y="23493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836240" y="21477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836240" y="19479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836240" y="1749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836240" y="15462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836240" y="1344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836240" y="114444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168520" y="240984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6008040" y="2409840"/>
              <a:ext cx="135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BL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6" name=""/>
            <p:cNvSpPr/>
            <p:nvPr/>
          </p:nvSpPr>
          <p:spPr>
            <a:xfrm rot="16200000">
              <a:off x="4105080" y="175032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831960" y="2862360"/>
              <a:ext cx="1517400" cy="120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831960" y="3892680"/>
              <a:ext cx="1517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831960" y="3719520"/>
              <a:ext cx="1517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831960" y="3544920"/>
              <a:ext cx="1517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831960" y="3379680"/>
              <a:ext cx="1517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831960" y="3206880"/>
              <a:ext cx="151740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831960" y="3035160"/>
              <a:ext cx="15174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831960" y="2862360"/>
              <a:ext cx="1517400" cy="1201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058760" y="3206880"/>
              <a:ext cx="306360" cy="8571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817640" y="3637080"/>
              <a:ext cx="304920" cy="4269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1211400" y="3017520"/>
              <a:ext cx="1440" cy="189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195560" y="3017880"/>
              <a:ext cx="39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1969920" y="3600360"/>
              <a:ext cx="1800" cy="36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954080" y="3600360"/>
              <a:ext cx="3816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211400" y="3206880"/>
              <a:ext cx="1440" cy="274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195560" y="3481560"/>
              <a:ext cx="39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969920" y="3637080"/>
              <a:ext cx="1800" cy="27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954080" y="3664080"/>
              <a:ext cx="381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1590840" y="4027320"/>
              <a:ext cx="144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864360" y="2867040"/>
              <a:ext cx="508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GA3OX2-1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745200" y="401004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669960" y="38354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669960" y="36640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669960" y="34909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669960" y="33256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8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745200" y="31528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669960" y="29797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669960" y="28051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082160" y="40752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893600" y="4075200"/>
              <a:ext cx="157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GA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7" name=""/>
            <p:cNvSpPr/>
            <p:nvPr/>
          </p:nvSpPr>
          <p:spPr>
            <a:xfrm rot="16200000">
              <a:off x="1440" y="338472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2913120" y="2870280"/>
              <a:ext cx="1452600" cy="1203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913120" y="3900600"/>
              <a:ext cx="145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2913120" y="3728880"/>
              <a:ext cx="1452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913120" y="3554280"/>
              <a:ext cx="1452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913120" y="3389400"/>
              <a:ext cx="14526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913120" y="3218040"/>
              <a:ext cx="145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913120" y="3043080"/>
              <a:ext cx="1452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913120" y="2870280"/>
              <a:ext cx="1452600" cy="1203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3130560" y="3218040"/>
              <a:ext cx="295200" cy="855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859200" y="3792600"/>
              <a:ext cx="290520" cy="2808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3274920" y="3025800"/>
              <a:ext cx="1800" cy="192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260880" y="302580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4003560" y="3719160"/>
              <a:ext cx="1800" cy="73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3989520" y="371952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3274920" y="3218040"/>
              <a:ext cx="1800" cy="274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3260880" y="3492360"/>
              <a:ext cx="349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003560" y="3792600"/>
              <a:ext cx="1800" cy="54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3989520" y="3846600"/>
              <a:ext cx="34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3643200" y="4036680"/>
              <a:ext cx="180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922120" y="2873520"/>
              <a:ext cx="267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D22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836080" y="40147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760840" y="38401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760840" y="366876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760840" y="349416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2760840" y="33289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8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2836080" y="31575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2760840" y="29844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760840" y="28098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3133080" y="40752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3911760" y="4075200"/>
              <a:ext cx="22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ABA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8" name=""/>
            <p:cNvSpPr/>
            <p:nvPr/>
          </p:nvSpPr>
          <p:spPr>
            <a:xfrm rot="16200000">
              <a:off x="2089080" y="341856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908600" y="2867040"/>
              <a:ext cx="1550880" cy="1200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908600" y="3868560"/>
              <a:ext cx="155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908600" y="3664080"/>
              <a:ext cx="155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908600" y="3465360"/>
              <a:ext cx="155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908600" y="3268800"/>
              <a:ext cx="1550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908600" y="3063960"/>
              <a:ext cx="1550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908600" y="2867040"/>
              <a:ext cx="1550880" cy="1200240"/>
            </a:xfrm>
            <a:prstGeom prst="rect">
              <a:avLst/>
            </a:pr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140440" y="3664080"/>
              <a:ext cx="311040" cy="40320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916600" y="3346560"/>
              <a:ext cx="309600" cy="7207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5295960" y="3607920"/>
              <a:ext cx="1440" cy="55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284800" y="3608280"/>
              <a:ext cx="2556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6072120" y="3076560"/>
              <a:ext cx="1800" cy="270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060960" y="3076560"/>
              <a:ext cx="2376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5295960" y="3664080"/>
              <a:ext cx="1440" cy="55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5284800" y="3719520"/>
              <a:ext cx="2556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072120" y="3346560"/>
              <a:ext cx="1800" cy="1951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6060960" y="3541680"/>
              <a:ext cx="237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5683320" y="4039920"/>
              <a:ext cx="144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941000" y="2901960"/>
              <a:ext cx="275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NPR1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826880" y="4008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751280" y="38116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826880" y="360504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751280" y="34084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826880" y="32115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751280" y="30067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826880" y="28098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152320" y="40752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6022440" y="4075200"/>
              <a:ext cx="136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SA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7" name=""/>
            <p:cNvSpPr/>
            <p:nvPr/>
          </p:nvSpPr>
          <p:spPr>
            <a:xfrm rot="16200000">
              <a:off x="4105080" y="343116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835200" y="4568760"/>
              <a:ext cx="1514160" cy="1254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835200" y="5643720"/>
              <a:ext cx="1514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835200" y="5468760"/>
              <a:ext cx="1514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835200" y="5288040"/>
              <a:ext cx="1514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835200" y="5105520"/>
              <a:ext cx="151416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835200" y="4927680"/>
              <a:ext cx="1514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835200" y="4751280"/>
              <a:ext cx="1514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835200" y="4568760"/>
              <a:ext cx="1514160" cy="1254240"/>
            </a:xfrm>
            <a:prstGeom prst="rect">
              <a:avLst/>
            </a:pr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985680" y="4927680"/>
              <a:ext cx="201600" cy="8953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490760" y="5578560"/>
              <a:ext cx="203040" cy="24444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995480" y="5448240"/>
              <a:ext cx="201600" cy="3747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1087560" y="4731840"/>
              <a:ext cx="1440" cy="1954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1076400" y="4732200"/>
              <a:ext cx="2520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1592280" y="5435280"/>
              <a:ext cx="0" cy="142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1581120" y="5435640"/>
              <a:ext cx="2556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3" name=""/>
            <p:cNvSpPr/>
            <p:nvPr/>
          </p:nvSpPr>
          <p:spPr>
            <a:xfrm flipV="1">
              <a:off x="2097000" y="5170320"/>
              <a:ext cx="1800" cy="277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2085840" y="5170320"/>
              <a:ext cx="2556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1087560" y="4927680"/>
              <a:ext cx="1440" cy="1666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1076400" y="5094360"/>
              <a:ext cx="2520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1592280" y="5578560"/>
              <a:ext cx="0" cy="903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1581120" y="5668920"/>
              <a:ext cx="255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2097000" y="5448240"/>
              <a:ext cx="1800" cy="162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2085840" y="5610240"/>
              <a:ext cx="2556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1339920" y="57992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1843200" y="57992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877320" y="4583160"/>
              <a:ext cx="52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Chitinase1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748440" y="57643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682560" y="55818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682560" y="54086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682560" y="522756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682560" y="50468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8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748440" y="48639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682560" y="468936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82560" y="45100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942480" y="58356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1467000" y="5835600"/>
              <a:ext cx="2170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ACC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1962720" y="5835600"/>
              <a:ext cx="272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eJA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5" name=""/>
            <p:cNvSpPr/>
            <p:nvPr/>
          </p:nvSpPr>
          <p:spPr>
            <a:xfrm rot="16200000">
              <a:off x="1440" y="507276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890800" y="4560840"/>
              <a:ext cx="1471680" cy="126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890800" y="5618160"/>
              <a:ext cx="147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890800" y="5400720"/>
              <a:ext cx="147168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890800" y="5192640"/>
              <a:ext cx="147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890800" y="4984920"/>
              <a:ext cx="147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890800" y="4768920"/>
              <a:ext cx="147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890800" y="4560840"/>
              <a:ext cx="1471680" cy="1266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3111480" y="5618160"/>
              <a:ext cx="297000" cy="2095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848040" y="5140440"/>
              <a:ext cx="295200" cy="68724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3257640" y="5597280"/>
              <a:ext cx="1440" cy="205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249720" y="5597640"/>
              <a:ext cx="2052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7" name=""/>
            <p:cNvSpPr/>
            <p:nvPr/>
          </p:nvSpPr>
          <p:spPr>
            <a:xfrm flipV="1">
              <a:off x="3995640" y="4773240"/>
              <a:ext cx="1800" cy="3668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3986280" y="4773600"/>
              <a:ext cx="223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3257640" y="5618160"/>
              <a:ext cx="1440" cy="126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3249720" y="5630760"/>
              <a:ext cx="2052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3995640" y="5140440"/>
              <a:ext cx="1800" cy="2365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3986280" y="5376960"/>
              <a:ext cx="223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3629160" y="5800320"/>
              <a:ext cx="144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2922480" y="4583160"/>
              <a:ext cx="253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CBF3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2801160" y="5781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801160" y="55720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801160" y="53560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801160" y="51451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801160" y="493704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801160" y="47214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801160" y="45133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3134880" y="58356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3875760" y="5835600"/>
              <a:ext cx="240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Cold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4" name=""/>
            <p:cNvSpPr/>
            <p:nvPr/>
          </p:nvSpPr>
          <p:spPr>
            <a:xfrm rot="16200000">
              <a:off x="2089080" y="505692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4906800" y="4560840"/>
              <a:ext cx="1546560" cy="1266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4906800" y="5670720"/>
              <a:ext cx="154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4906800" y="5513400"/>
              <a:ext cx="154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4906800" y="5349960"/>
              <a:ext cx="154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4906800" y="5192640"/>
              <a:ext cx="154656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906800" y="5037120"/>
              <a:ext cx="1546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906800" y="4881600"/>
              <a:ext cx="154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906800" y="4718160"/>
              <a:ext cx="1546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4906800" y="4560840"/>
              <a:ext cx="1546560" cy="1266840"/>
            </a:xfrm>
            <a:prstGeom prst="rect">
              <a:avLst/>
            </a:pr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5137200" y="5513400"/>
              <a:ext cx="311040" cy="3142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5911920" y="5049720"/>
              <a:ext cx="311040" cy="77796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6" name=""/>
            <p:cNvSpPr/>
            <p:nvPr/>
          </p:nvSpPr>
          <p:spPr>
            <a:xfrm flipV="1">
              <a:off x="5292720" y="5370120"/>
              <a:ext cx="1440" cy="142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283360" y="5370480"/>
              <a:ext cx="237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8" name=""/>
            <p:cNvSpPr/>
            <p:nvPr/>
          </p:nvSpPr>
          <p:spPr>
            <a:xfrm flipV="1">
              <a:off x="6066000" y="4689000"/>
              <a:ext cx="1440" cy="3603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6056280" y="4689360"/>
              <a:ext cx="237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5292720" y="5513400"/>
              <a:ext cx="1440" cy="921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5283360" y="5605560"/>
              <a:ext cx="2376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6066000" y="5049720"/>
              <a:ext cx="1440" cy="2476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6056280" y="5297400"/>
              <a:ext cx="237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4" name=""/>
            <p:cNvSpPr/>
            <p:nvPr/>
          </p:nvSpPr>
          <p:spPr>
            <a:xfrm flipV="1">
              <a:off x="5678640" y="5800320"/>
              <a:ext cx="1440" cy="27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953960" y="4559400"/>
              <a:ext cx="328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HSC70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826880" y="57657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749840" y="56102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826880" y="54529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749840" y="52894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826880" y="51325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749840" y="49766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2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4826880" y="481824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4749840" y="46562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3.5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4826880" y="45007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5144400" y="58356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934240" y="5835600"/>
              <a:ext cx="255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Heat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7" name=""/>
            <p:cNvSpPr/>
            <p:nvPr/>
          </p:nvSpPr>
          <p:spPr>
            <a:xfrm rot="16200000">
              <a:off x="4105080" y="509976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838080" y="6310440"/>
              <a:ext cx="1511280" cy="1255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838080" y="7386480"/>
              <a:ext cx="1511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838080" y="7210440"/>
              <a:ext cx="1511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838080" y="7031160"/>
              <a:ext cx="1511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838080" y="6846840"/>
              <a:ext cx="1511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838080" y="6667560"/>
              <a:ext cx="1511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838080" y="6491160"/>
              <a:ext cx="1511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838080" y="6310440"/>
              <a:ext cx="1511280" cy="125568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1063800" y="6667560"/>
              <a:ext cx="304560" cy="8985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820880" y="7054920"/>
              <a:ext cx="299880" cy="5112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8" name=""/>
            <p:cNvSpPr/>
            <p:nvPr/>
          </p:nvSpPr>
          <p:spPr>
            <a:xfrm flipV="1">
              <a:off x="1214280" y="6458040"/>
              <a:ext cx="1800" cy="209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206360" y="6458040"/>
              <a:ext cx="22320" cy="3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0" name=""/>
            <p:cNvSpPr/>
            <p:nvPr/>
          </p:nvSpPr>
          <p:spPr>
            <a:xfrm flipV="1">
              <a:off x="1969920" y="6879960"/>
              <a:ext cx="1800" cy="174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959120" y="6880320"/>
              <a:ext cx="219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1214280" y="6667560"/>
              <a:ext cx="1800" cy="174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206360" y="6842160"/>
              <a:ext cx="2232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969920" y="7054920"/>
              <a:ext cx="1800" cy="1299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959120" y="7184880"/>
              <a:ext cx="21960" cy="3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6" name=""/>
            <p:cNvSpPr/>
            <p:nvPr/>
          </p:nvSpPr>
          <p:spPr>
            <a:xfrm flipV="1">
              <a:off x="1595520" y="754236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875880" y="6316560"/>
              <a:ext cx="267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D22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751680" y="75103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681120" y="73296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681120" y="71550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681120" y="697392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681120" y="67928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8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751680" y="66088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681120" y="64342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681120" y="62532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075680" y="75834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741320" y="7583400"/>
              <a:ext cx="451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Drought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8" name=""/>
            <p:cNvSpPr/>
            <p:nvPr/>
          </p:nvSpPr>
          <p:spPr>
            <a:xfrm rot="16200000">
              <a:off x="1440" y="681120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2890800" y="6318360"/>
              <a:ext cx="1474920" cy="1251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2890800" y="7388280"/>
              <a:ext cx="1474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2890800" y="7213680"/>
              <a:ext cx="1474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2890800" y="7034040"/>
              <a:ext cx="1474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2890800" y="6853320"/>
              <a:ext cx="147492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2890800" y="6672240"/>
              <a:ext cx="1474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2890800" y="6497640"/>
              <a:ext cx="1474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2890800" y="6318360"/>
              <a:ext cx="1474920" cy="125100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111480" y="6672240"/>
              <a:ext cx="295200" cy="8971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3849840" y="7383600"/>
              <a:ext cx="293400" cy="1857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59" name=""/>
            <p:cNvSpPr/>
            <p:nvPr/>
          </p:nvSpPr>
          <p:spPr>
            <a:xfrm flipV="1">
              <a:off x="3259080" y="6467040"/>
              <a:ext cx="1800" cy="204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249720" y="6467400"/>
              <a:ext cx="2196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1" name=""/>
            <p:cNvSpPr/>
            <p:nvPr/>
          </p:nvSpPr>
          <p:spPr>
            <a:xfrm flipV="1">
              <a:off x="3994200" y="7349760"/>
              <a:ext cx="1440" cy="33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984480" y="7350120"/>
              <a:ext cx="2412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259080" y="6672240"/>
              <a:ext cx="1800" cy="174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249720" y="6846840"/>
              <a:ext cx="2196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3994200" y="7383600"/>
              <a:ext cx="1440" cy="252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984480" y="7408800"/>
              <a:ext cx="2412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7" name=""/>
            <p:cNvSpPr/>
            <p:nvPr/>
          </p:nvSpPr>
          <p:spPr>
            <a:xfrm flipV="1">
              <a:off x="3630600" y="7543440"/>
              <a:ext cx="1440" cy="2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2926800" y="6321600"/>
              <a:ext cx="267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D22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815560" y="750888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2746440" y="73278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2746440" y="715320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746440" y="69724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6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746440" y="67928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0.8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815560" y="66117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746440" y="643716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2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2746440" y="625644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1.4</a:t>
              </a:r>
              <a:endParaRPr b="0" lang="en-US" sz="7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129840" y="75834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904920" y="75834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Salt</a:t>
              </a:r>
              <a:endParaRPr b="0" lang="en-US" sz="9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9" name=""/>
            <p:cNvSpPr/>
            <p:nvPr/>
          </p:nvSpPr>
          <p:spPr>
            <a:xfrm rot="16200000">
              <a:off x="2082600" y="6838200"/>
              <a:ext cx="114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돋움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4T00:15:49Z</dcterms:created>
  <dc:creator>박충모</dc:creator>
  <dc:description/>
  <dc:language>en-US</dc:language>
  <cp:lastModifiedBy>박충모</cp:lastModifiedBy>
  <dcterms:modified xsi:type="dcterms:W3CDTF">2008-11-04T00:41:36Z</dcterms:modified>
  <cp:revision>11</cp:revision>
  <dc:subject/>
  <dc:title>슬라이드 1</dc:title>
</cp:coreProperties>
</file>